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51" autoAdjust="0"/>
    <p:restoredTop sz="94660"/>
  </p:normalViewPr>
  <p:slideViewPr>
    <p:cSldViewPr>
      <p:cViewPr>
        <p:scale>
          <a:sx n="118" d="100"/>
          <a:sy n="118" d="100"/>
        </p:scale>
        <p:origin x="-1716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hSNP\Island\pca25x4882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hSNP\Island\pca25x4882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hSNP\Island\pca25x4882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62761472997688"/>
          <c:y val="2.6853762686776157E-2"/>
          <c:w val="0.74433114610673667"/>
          <c:h val="0.82713045417989994"/>
        </c:manualLayout>
      </c:layout>
      <c:scatterChart>
        <c:scatterStyle val="lineMarker"/>
        <c:varyColors val="0"/>
        <c:ser>
          <c:idx val="0"/>
          <c:order val="0"/>
          <c:tx>
            <c:strRef>
              <c:f>xpca20x25!$C$108</c:f>
              <c:strCache>
                <c:ptCount val="1"/>
                <c:pt idx="0">
                  <c:v>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FF0000"/>
                </a:solidFill>
                <a:round/>
              </a:ln>
              <a:effectLst/>
            </c:spPr>
          </c:marker>
          <c:xVal>
            <c:numRef>
              <c:f>xpca20x25!$B$109:$B$133</c:f>
              <c:numCache>
                <c:formatCode>General</c:formatCode>
                <c:ptCount val="25"/>
                <c:pt idx="0">
                  <c:v>3.5472020000000028E-2</c:v>
                </c:pt>
                <c:pt idx="1">
                  <c:v>2.83774421052632E-2</c:v>
                </c:pt>
                <c:pt idx="2">
                  <c:v>3.1683757142857184E-2</c:v>
                </c:pt>
                <c:pt idx="3">
                  <c:v>2.6649614285714322E-2</c:v>
                </c:pt>
                <c:pt idx="4">
                  <c:v>3.8340766666666665E-2</c:v>
                </c:pt>
                <c:pt idx="5">
                  <c:v>3.6883528571428618E-2</c:v>
                </c:pt>
                <c:pt idx="6">
                  <c:v>3.274792222222226E-2</c:v>
                </c:pt>
                <c:pt idx="7">
                  <c:v>2.9412573913043485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605E-2</c:v>
                </c:pt>
                <c:pt idx="11">
                  <c:v>2.7641604347826112E-2</c:v>
                </c:pt>
                <c:pt idx="12">
                  <c:v>2.8748635714285709E-2</c:v>
                </c:pt>
                <c:pt idx="13">
                  <c:v>1.7389557692307725E-2</c:v>
                </c:pt>
                <c:pt idx="14">
                  <c:v>8.6616690909091069E-3</c:v>
                </c:pt>
                <c:pt idx="15">
                  <c:v>1.3929741176470584E-2</c:v>
                </c:pt>
                <c:pt idx="16">
                  <c:v>1.5568889473684224E-2</c:v>
                </c:pt>
                <c:pt idx="17">
                  <c:v>-1.9617862068965538E-2</c:v>
                </c:pt>
                <c:pt idx="18">
                  <c:v>-3.0654957142857153E-2</c:v>
                </c:pt>
                <c:pt idx="19">
                  <c:v>-3.9855700000000008E-2</c:v>
                </c:pt>
                <c:pt idx="20">
                  <c:v>-9.3535738461538551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17E-2</c:v>
                </c:pt>
                <c:pt idx="24">
                  <c:v>-8.1916060000000041E-2</c:v>
                </c:pt>
              </c:numCache>
            </c:numRef>
          </c:xVal>
          <c:yVal>
            <c:numRef>
              <c:f>xpca20x25!$C$109:$C$133</c:f>
              <c:numCache>
                <c:formatCode>General</c:formatCode>
                <c:ptCount val="25"/>
                <c:pt idx="0">
                  <c:v>0.17025509999999999</c:v>
                </c:pt>
                <c:pt idx="4">
                  <c:v>2.2742241666666694E-2</c:v>
                </c:pt>
                <c:pt idx="5">
                  <c:v>2.2172514285714311E-2</c:v>
                </c:pt>
                <c:pt idx="6">
                  <c:v>1.6403711111111129E-2</c:v>
                </c:pt>
                <c:pt idx="18">
                  <c:v>-8.7368557142857156E-2</c:v>
                </c:pt>
                <c:pt idx="20">
                  <c:v>1.8690946153846155E-2</c:v>
                </c:pt>
                <c:pt idx="21">
                  <c:v>2.8808742857142855E-2</c:v>
                </c:pt>
                <c:pt idx="22">
                  <c:v>3.1552499999999997E-2</c:v>
                </c:pt>
                <c:pt idx="23">
                  <c:v>2.3686842857142853E-2</c:v>
                </c:pt>
                <c:pt idx="24">
                  <c:v>2.0727059999999981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EE1-469A-922D-24E5F85DC3CB}"/>
            </c:ext>
          </c:extLst>
        </c:ser>
        <c:ser>
          <c:idx val="1"/>
          <c:order val="1"/>
          <c:tx>
            <c:strRef>
              <c:f>xpca20x25!$D$108</c:f>
              <c:strCache>
                <c:ptCount val="1"/>
                <c:pt idx="0">
                  <c:v>Nordi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0000FF"/>
                </a:solidFill>
                <a:round/>
              </a:ln>
              <a:effectLst/>
            </c:spPr>
          </c:marker>
          <c:xVal>
            <c:numRef>
              <c:f>xpca20x25!$B$109:$B$133</c:f>
              <c:numCache>
                <c:formatCode>General</c:formatCode>
                <c:ptCount val="25"/>
                <c:pt idx="0">
                  <c:v>3.5472020000000028E-2</c:v>
                </c:pt>
                <c:pt idx="1">
                  <c:v>2.83774421052632E-2</c:v>
                </c:pt>
                <c:pt idx="2">
                  <c:v>3.1683757142857184E-2</c:v>
                </c:pt>
                <c:pt idx="3">
                  <c:v>2.6649614285714322E-2</c:v>
                </c:pt>
                <c:pt idx="4">
                  <c:v>3.8340766666666665E-2</c:v>
                </c:pt>
                <c:pt idx="5">
                  <c:v>3.6883528571428618E-2</c:v>
                </c:pt>
                <c:pt idx="6">
                  <c:v>3.274792222222226E-2</c:v>
                </c:pt>
                <c:pt idx="7">
                  <c:v>2.9412573913043485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605E-2</c:v>
                </c:pt>
                <c:pt idx="11">
                  <c:v>2.7641604347826112E-2</c:v>
                </c:pt>
                <c:pt idx="12">
                  <c:v>2.8748635714285709E-2</c:v>
                </c:pt>
                <c:pt idx="13">
                  <c:v>1.7389557692307725E-2</c:v>
                </c:pt>
                <c:pt idx="14">
                  <c:v>8.6616690909091069E-3</c:v>
                </c:pt>
                <c:pt idx="15">
                  <c:v>1.3929741176470584E-2</c:v>
                </c:pt>
                <c:pt idx="16">
                  <c:v>1.5568889473684224E-2</c:v>
                </c:pt>
                <c:pt idx="17">
                  <c:v>-1.9617862068965538E-2</c:v>
                </c:pt>
                <c:pt idx="18">
                  <c:v>-3.0654957142857153E-2</c:v>
                </c:pt>
                <c:pt idx="19">
                  <c:v>-3.9855700000000008E-2</c:v>
                </c:pt>
                <c:pt idx="20">
                  <c:v>-9.3535738461538551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17E-2</c:v>
                </c:pt>
                <c:pt idx="24">
                  <c:v>-8.1916060000000041E-2</c:v>
                </c:pt>
              </c:numCache>
            </c:numRef>
          </c:xVal>
          <c:yVal>
            <c:numRef>
              <c:f>xpca20x25!$D$109:$D$133</c:f>
              <c:numCache>
                <c:formatCode>General</c:formatCode>
                <c:ptCount val="25"/>
                <c:pt idx="1">
                  <c:v>6.6453105263157855E-2</c:v>
                </c:pt>
                <c:pt idx="2">
                  <c:v>5.3869671428571519E-2</c:v>
                </c:pt>
                <c:pt idx="3">
                  <c:v>3.4167142857142868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EE1-469A-922D-24E5F85DC3CB}"/>
            </c:ext>
          </c:extLst>
        </c:ser>
        <c:ser>
          <c:idx val="2"/>
          <c:order val="2"/>
          <c:tx>
            <c:strRef>
              <c:f>xpca20x25!$E$108</c:f>
              <c:strCache>
                <c:ptCount val="1"/>
                <c:pt idx="0">
                  <c:v>Mediterranean 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FF7C80"/>
              </a:solidFill>
              <a:ln w="9525">
                <a:solidFill>
                  <a:srgbClr val="FF7C80"/>
                </a:solidFill>
                <a:round/>
              </a:ln>
              <a:effectLst/>
            </c:spPr>
          </c:marker>
          <c:xVal>
            <c:numRef>
              <c:f>xpca20x25!$B$109:$B$133</c:f>
              <c:numCache>
                <c:formatCode>General</c:formatCode>
                <c:ptCount val="25"/>
                <c:pt idx="0">
                  <c:v>3.5472020000000028E-2</c:v>
                </c:pt>
                <c:pt idx="1">
                  <c:v>2.83774421052632E-2</c:v>
                </c:pt>
                <c:pt idx="2">
                  <c:v>3.1683757142857184E-2</c:v>
                </c:pt>
                <c:pt idx="3">
                  <c:v>2.6649614285714322E-2</c:v>
                </c:pt>
                <c:pt idx="4">
                  <c:v>3.8340766666666665E-2</c:v>
                </c:pt>
                <c:pt idx="5">
                  <c:v>3.6883528571428618E-2</c:v>
                </c:pt>
                <c:pt idx="6">
                  <c:v>3.274792222222226E-2</c:v>
                </c:pt>
                <c:pt idx="7">
                  <c:v>2.9412573913043485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605E-2</c:v>
                </c:pt>
                <c:pt idx="11">
                  <c:v>2.7641604347826112E-2</c:v>
                </c:pt>
                <c:pt idx="12">
                  <c:v>2.8748635714285709E-2</c:v>
                </c:pt>
                <c:pt idx="13">
                  <c:v>1.7389557692307725E-2</c:v>
                </c:pt>
                <c:pt idx="14">
                  <c:v>8.6616690909091069E-3</c:v>
                </c:pt>
                <c:pt idx="15">
                  <c:v>1.3929741176470584E-2</c:v>
                </c:pt>
                <c:pt idx="16">
                  <c:v>1.5568889473684224E-2</c:v>
                </c:pt>
                <c:pt idx="17">
                  <c:v>-1.9617862068965538E-2</c:v>
                </c:pt>
                <c:pt idx="18">
                  <c:v>-3.0654957142857153E-2</c:v>
                </c:pt>
                <c:pt idx="19">
                  <c:v>-3.9855700000000008E-2</c:v>
                </c:pt>
                <c:pt idx="20">
                  <c:v>-9.3535738461538551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17E-2</c:v>
                </c:pt>
                <c:pt idx="24">
                  <c:v>-8.1916060000000041E-2</c:v>
                </c:pt>
              </c:numCache>
            </c:numRef>
          </c:xVal>
          <c:yVal>
            <c:numRef>
              <c:f>xpca20x25!$E$109:$E$133</c:f>
              <c:numCache>
                <c:formatCode>General</c:formatCode>
                <c:ptCount val="25"/>
                <c:pt idx="10">
                  <c:v>-2.3297899999999993E-2</c:v>
                </c:pt>
                <c:pt idx="11">
                  <c:v>-3.41296782608696E-2</c:v>
                </c:pt>
                <c:pt idx="12">
                  <c:v>-2.2541260714285756E-2</c:v>
                </c:pt>
                <c:pt idx="13">
                  <c:v>-3.5078150000000009E-2</c:v>
                </c:pt>
                <c:pt idx="14">
                  <c:v>-3.2851218181818249E-2</c:v>
                </c:pt>
                <c:pt idx="15">
                  <c:v>-4.2109988235294105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EE1-469A-922D-24E5F85DC3CB}"/>
            </c:ext>
          </c:extLst>
        </c:ser>
        <c:ser>
          <c:idx val="3"/>
          <c:order val="3"/>
          <c:tx>
            <c:strRef>
              <c:f>xpca20x25!$F$108</c:f>
              <c:strCache>
                <c:ptCount val="1"/>
                <c:pt idx="0">
                  <c:v>Continenta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3399FF"/>
              </a:solidFill>
              <a:ln w="9525">
                <a:solidFill>
                  <a:srgbClr val="3399FF"/>
                </a:solidFill>
                <a:round/>
              </a:ln>
              <a:effectLst/>
            </c:spPr>
          </c:marker>
          <c:xVal>
            <c:numRef>
              <c:f>xpca20x25!$B$109:$B$133</c:f>
              <c:numCache>
                <c:formatCode>General</c:formatCode>
                <c:ptCount val="25"/>
                <c:pt idx="0">
                  <c:v>3.5472020000000028E-2</c:v>
                </c:pt>
                <c:pt idx="1">
                  <c:v>2.83774421052632E-2</c:v>
                </c:pt>
                <c:pt idx="2">
                  <c:v>3.1683757142857184E-2</c:v>
                </c:pt>
                <c:pt idx="3">
                  <c:v>2.6649614285714322E-2</c:v>
                </c:pt>
                <c:pt idx="4">
                  <c:v>3.8340766666666665E-2</c:v>
                </c:pt>
                <c:pt idx="5">
                  <c:v>3.6883528571428618E-2</c:v>
                </c:pt>
                <c:pt idx="6">
                  <c:v>3.274792222222226E-2</c:v>
                </c:pt>
                <c:pt idx="7">
                  <c:v>2.9412573913043485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605E-2</c:v>
                </c:pt>
                <c:pt idx="11">
                  <c:v>2.7641604347826112E-2</c:v>
                </c:pt>
                <c:pt idx="12">
                  <c:v>2.8748635714285709E-2</c:v>
                </c:pt>
                <c:pt idx="13">
                  <c:v>1.7389557692307725E-2</c:v>
                </c:pt>
                <c:pt idx="14">
                  <c:v>8.6616690909091069E-3</c:v>
                </c:pt>
                <c:pt idx="15">
                  <c:v>1.3929741176470584E-2</c:v>
                </c:pt>
                <c:pt idx="16">
                  <c:v>1.5568889473684224E-2</c:v>
                </c:pt>
                <c:pt idx="17">
                  <c:v>-1.9617862068965538E-2</c:v>
                </c:pt>
                <c:pt idx="18">
                  <c:v>-3.0654957142857153E-2</c:v>
                </c:pt>
                <c:pt idx="19">
                  <c:v>-3.9855700000000008E-2</c:v>
                </c:pt>
                <c:pt idx="20">
                  <c:v>-9.3535738461538551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17E-2</c:v>
                </c:pt>
                <c:pt idx="24">
                  <c:v>-8.1916060000000041E-2</c:v>
                </c:pt>
              </c:numCache>
            </c:numRef>
          </c:xVal>
          <c:yVal>
            <c:numRef>
              <c:f>xpca20x25!$F$109:$F$133</c:f>
              <c:numCache>
                <c:formatCode>General</c:formatCode>
                <c:ptCount val="25"/>
                <c:pt idx="7">
                  <c:v>-6.9971978260869585E-3</c:v>
                </c:pt>
                <c:pt idx="8">
                  <c:v>-1.4487293333333338E-2</c:v>
                </c:pt>
                <c:pt idx="9">
                  <c:v>-2.6441131818181841E-2</c:v>
                </c:pt>
                <c:pt idx="16">
                  <c:v>-3.9890521052631578E-2</c:v>
                </c:pt>
                <c:pt idx="17">
                  <c:v>-4.538709655172421E-2</c:v>
                </c:pt>
                <c:pt idx="19">
                  <c:v>-1.1892638095238111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EE1-469A-922D-24E5F85DC3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153984"/>
        <c:axId val="96155904"/>
      </c:scatterChart>
      <c:valAx>
        <c:axId val="96153984"/>
        <c:scaling>
          <c:orientation val="minMax"/>
          <c:max val="6.0000000000000039E-2"/>
          <c:min val="-0.1200000000000000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155904"/>
        <c:crossesAt val="-0.1"/>
        <c:crossBetween val="midCat"/>
      </c:valAx>
      <c:valAx>
        <c:axId val="96155904"/>
        <c:scaling>
          <c:orientation val="minMax"/>
          <c:min val="-0.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2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153984"/>
        <c:crossesAt val="-0.12000000000000002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8666730295076767"/>
          <c:y val="2.8268486346166872E-2"/>
          <c:w val="0.5130695935735311"/>
          <c:h val="0.28523737333612775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62761472997688"/>
          <c:y val="2.6853762686776157E-2"/>
          <c:w val="0.74433114610673667"/>
          <c:h val="0.82713045417989994"/>
        </c:manualLayout>
      </c:layout>
      <c:scatterChart>
        <c:scatterStyle val="lineMarker"/>
        <c:varyColors val="0"/>
        <c:ser>
          <c:idx val="0"/>
          <c:order val="0"/>
          <c:tx>
            <c:strRef>
              <c:f>xpca20x25!$C$135</c:f>
              <c:strCache>
                <c:ptCount val="1"/>
                <c:pt idx="0">
                  <c:v>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FF0000"/>
                </a:solidFill>
                <a:round/>
              </a:ln>
              <a:effectLst/>
            </c:spPr>
          </c:marker>
          <c:xVal>
            <c:numRef>
              <c:f>xpca20x25!$B$136:$B$160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C$136:$C$160</c:f>
              <c:numCache>
                <c:formatCode>General</c:formatCode>
                <c:ptCount val="25"/>
                <c:pt idx="0">
                  <c:v>0.14773280000000014</c:v>
                </c:pt>
                <c:pt idx="4">
                  <c:v>-3.4315375000000002E-2</c:v>
                </c:pt>
                <c:pt idx="5">
                  <c:v>-3.1298628571428601E-2</c:v>
                </c:pt>
                <c:pt idx="6">
                  <c:v>-2.4918922222222219E-2</c:v>
                </c:pt>
                <c:pt idx="18">
                  <c:v>0.16366864285714294</c:v>
                </c:pt>
                <c:pt idx="20">
                  <c:v>-1.8437184615384634E-2</c:v>
                </c:pt>
                <c:pt idx="21">
                  <c:v>-3.3230838095238101E-2</c:v>
                </c:pt>
                <c:pt idx="22">
                  <c:v>-3.7835177777777868E-2</c:v>
                </c:pt>
                <c:pt idx="23">
                  <c:v>-2.6441000000000034E-2</c:v>
                </c:pt>
                <c:pt idx="24">
                  <c:v>-2.1533820000000002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71C-451F-82FA-B8B4221E09B4}"/>
            </c:ext>
          </c:extLst>
        </c:ser>
        <c:ser>
          <c:idx val="1"/>
          <c:order val="1"/>
          <c:tx>
            <c:strRef>
              <c:f>xpca20x25!$D$135</c:f>
              <c:strCache>
                <c:ptCount val="1"/>
                <c:pt idx="0">
                  <c:v>Nordi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0000FF"/>
                </a:solidFill>
                <a:round/>
              </a:ln>
              <a:effectLst/>
            </c:spPr>
          </c:marker>
          <c:xVal>
            <c:numRef>
              <c:f>xpca20x25!$B$136:$B$160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D$136:$D$160</c:f>
              <c:numCache>
                <c:formatCode>General</c:formatCode>
                <c:ptCount val="25"/>
                <c:pt idx="1">
                  <c:v>1.873546315789474E-2</c:v>
                </c:pt>
                <c:pt idx="2">
                  <c:v>-5.5252695714285791E-3</c:v>
                </c:pt>
                <c:pt idx="3">
                  <c:v>7.0292471428571538E-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71C-451F-82FA-B8B4221E09B4}"/>
            </c:ext>
          </c:extLst>
        </c:ser>
        <c:ser>
          <c:idx val="2"/>
          <c:order val="2"/>
          <c:tx>
            <c:strRef>
              <c:f>xpca20x25!$E$135</c:f>
              <c:strCache>
                <c:ptCount val="1"/>
                <c:pt idx="0">
                  <c:v>Mediterranean 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FF7C80"/>
              </a:solidFill>
              <a:ln w="9525">
                <a:solidFill>
                  <a:srgbClr val="FF7C80"/>
                </a:solidFill>
                <a:round/>
              </a:ln>
              <a:effectLst/>
            </c:spPr>
          </c:marker>
          <c:xVal>
            <c:numRef>
              <c:f>xpca20x25!$B$136:$B$160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E$136:$E$160</c:f>
              <c:numCache>
                <c:formatCode>General</c:formatCode>
                <c:ptCount val="25"/>
                <c:pt idx="10">
                  <c:v>-2.0854513043478271E-2</c:v>
                </c:pt>
                <c:pt idx="11">
                  <c:v>-4.9302643478260903E-2</c:v>
                </c:pt>
                <c:pt idx="12">
                  <c:v>-2.7504975000000011E-2</c:v>
                </c:pt>
                <c:pt idx="13">
                  <c:v>-8.7353726923077024E-3</c:v>
                </c:pt>
                <c:pt idx="14">
                  <c:v>-3.1256040909090946E-3</c:v>
                </c:pt>
                <c:pt idx="15">
                  <c:v>1.500591176470588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71C-451F-82FA-B8B4221E09B4}"/>
            </c:ext>
          </c:extLst>
        </c:ser>
        <c:ser>
          <c:idx val="3"/>
          <c:order val="3"/>
          <c:tx>
            <c:strRef>
              <c:f>xpca20x25!$F$135</c:f>
              <c:strCache>
                <c:ptCount val="1"/>
                <c:pt idx="0">
                  <c:v>Continenta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3399FF"/>
              </a:solidFill>
              <a:ln w="9525">
                <a:solidFill>
                  <a:srgbClr val="3399FF"/>
                </a:solidFill>
                <a:round/>
              </a:ln>
              <a:effectLst/>
            </c:spPr>
          </c:marker>
          <c:xVal>
            <c:numRef>
              <c:f>xpca20x25!$B$136:$B$160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F$136:$F$160</c:f>
              <c:numCache>
                <c:formatCode>General</c:formatCode>
                <c:ptCount val="25"/>
                <c:pt idx="7">
                  <c:v>-1.6013560434782626E-2</c:v>
                </c:pt>
                <c:pt idx="8">
                  <c:v>-2.2962213333333332E-2</c:v>
                </c:pt>
                <c:pt idx="9">
                  <c:v>-2.8296981818181795E-2</c:v>
                </c:pt>
                <c:pt idx="16">
                  <c:v>1.0229043684210527E-2</c:v>
                </c:pt>
                <c:pt idx="17">
                  <c:v>5.6422413793103483E-2</c:v>
                </c:pt>
                <c:pt idx="19">
                  <c:v>3.2743319047619096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71C-451F-82FA-B8B4221E09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188288"/>
        <c:axId val="96190848"/>
      </c:scatterChart>
      <c:valAx>
        <c:axId val="96188288"/>
        <c:scaling>
          <c:orientation val="minMax"/>
          <c:max val="6.0000000000000032E-2"/>
          <c:min val="-0.1200000000000000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190848"/>
        <c:crossesAt val="-0.1"/>
        <c:crossBetween val="midCat"/>
      </c:valAx>
      <c:valAx>
        <c:axId val="96190848"/>
        <c:scaling>
          <c:orientation val="minMax"/>
          <c:min val="-0.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3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188288"/>
        <c:crossesAt val="-0.12000000000000002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62761472997688"/>
          <c:y val="2.6853762686776157E-2"/>
          <c:w val="0.74433114610673667"/>
          <c:h val="0.82713045417989994"/>
        </c:manualLayout>
      </c:layout>
      <c:scatterChart>
        <c:scatterStyle val="lineMarker"/>
        <c:varyColors val="0"/>
        <c:ser>
          <c:idx val="0"/>
          <c:order val="0"/>
          <c:tx>
            <c:strRef>
              <c:f>xpca20x25!$C$162</c:f>
              <c:strCache>
                <c:ptCount val="1"/>
                <c:pt idx="0">
                  <c:v>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FF0000"/>
                </a:solidFill>
                <a:round/>
              </a:ln>
              <a:effectLst/>
            </c:spPr>
          </c:marker>
          <c:xVal>
            <c:numRef>
              <c:f>xpca20x25!$B$163:$B$187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C$163:$C$187</c:f>
              <c:numCache>
                <c:formatCode>General</c:formatCode>
                <c:ptCount val="25"/>
                <c:pt idx="0">
                  <c:v>-0.1713771</c:v>
                </c:pt>
                <c:pt idx="4">
                  <c:v>5.0843100000000069E-5</c:v>
                </c:pt>
                <c:pt idx="5">
                  <c:v>-1.7250411428571429E-3</c:v>
                </c:pt>
                <c:pt idx="6">
                  <c:v>1.6695273444444457E-3</c:v>
                </c:pt>
                <c:pt idx="18">
                  <c:v>4.9822178571428573E-2</c:v>
                </c:pt>
                <c:pt idx="20">
                  <c:v>-2.491996615384615E-3</c:v>
                </c:pt>
                <c:pt idx="21">
                  <c:v>-6.684540000000001E-3</c:v>
                </c:pt>
                <c:pt idx="22">
                  <c:v>-9.0038050000000105E-3</c:v>
                </c:pt>
                <c:pt idx="23">
                  <c:v>-4.158447142857148E-3</c:v>
                </c:pt>
                <c:pt idx="24">
                  <c:v>-2.2421532000000037E-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E57-4E88-AF58-C12A225ADDDA}"/>
            </c:ext>
          </c:extLst>
        </c:ser>
        <c:ser>
          <c:idx val="1"/>
          <c:order val="1"/>
          <c:tx>
            <c:strRef>
              <c:f>xpca20x25!$D$162</c:f>
              <c:strCache>
                <c:ptCount val="1"/>
                <c:pt idx="0">
                  <c:v>Nordi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rgbClr val="0000FF"/>
                </a:solidFill>
                <a:round/>
              </a:ln>
              <a:effectLst/>
            </c:spPr>
          </c:marker>
          <c:xVal>
            <c:numRef>
              <c:f>xpca20x25!$B$163:$B$187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D$163:$D$187</c:f>
              <c:numCache>
                <c:formatCode>General</c:formatCode>
                <c:ptCount val="25"/>
                <c:pt idx="1">
                  <c:v>1.4954994736842099E-2</c:v>
                </c:pt>
                <c:pt idx="2">
                  <c:v>9.4635093877551132E-2</c:v>
                </c:pt>
                <c:pt idx="3">
                  <c:v>2.5910464285714287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E57-4E88-AF58-C12A225ADDDA}"/>
            </c:ext>
          </c:extLst>
        </c:ser>
        <c:ser>
          <c:idx val="2"/>
          <c:order val="2"/>
          <c:tx>
            <c:strRef>
              <c:f>xpca20x25!$E$162</c:f>
              <c:strCache>
                <c:ptCount val="1"/>
                <c:pt idx="0">
                  <c:v>Mediterranean is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FF7C80"/>
              </a:solidFill>
              <a:ln w="9525">
                <a:solidFill>
                  <a:srgbClr val="FF7C80"/>
                </a:solidFill>
                <a:round/>
              </a:ln>
              <a:effectLst/>
            </c:spPr>
          </c:marker>
          <c:xVal>
            <c:numRef>
              <c:f>xpca20x25!$B$163:$B$187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E$163:$E$187</c:f>
              <c:numCache>
                <c:formatCode>General</c:formatCode>
                <c:ptCount val="25"/>
                <c:pt idx="10">
                  <c:v>-2.4576643478260898E-2</c:v>
                </c:pt>
                <c:pt idx="11">
                  <c:v>-5.8945026086956495E-2</c:v>
                </c:pt>
                <c:pt idx="12">
                  <c:v>-2.0745775000000011E-2</c:v>
                </c:pt>
                <c:pt idx="13">
                  <c:v>-1.7336457692307704E-2</c:v>
                </c:pt>
                <c:pt idx="14">
                  <c:v>-2.2273945454545519E-2</c:v>
                </c:pt>
                <c:pt idx="15">
                  <c:v>1.4189921176470579E-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E57-4E88-AF58-C12A225ADDDA}"/>
            </c:ext>
          </c:extLst>
        </c:ser>
        <c:ser>
          <c:idx val="3"/>
          <c:order val="3"/>
          <c:tx>
            <c:strRef>
              <c:f>xpca20x25!$F$162</c:f>
              <c:strCache>
                <c:ptCount val="1"/>
                <c:pt idx="0">
                  <c:v>Continenta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rgbClr val="3399FF"/>
              </a:solidFill>
              <a:ln w="9525">
                <a:solidFill>
                  <a:srgbClr val="3399FF"/>
                </a:solidFill>
                <a:round/>
              </a:ln>
              <a:effectLst/>
            </c:spPr>
          </c:marker>
          <c:xVal>
            <c:numRef>
              <c:f>xpca20x25!$B$163:$B$187</c:f>
              <c:numCache>
                <c:formatCode>General</c:formatCode>
                <c:ptCount val="25"/>
                <c:pt idx="0">
                  <c:v>3.5472020000000014E-2</c:v>
                </c:pt>
                <c:pt idx="1">
                  <c:v>2.83774421052632E-2</c:v>
                </c:pt>
                <c:pt idx="2">
                  <c:v>3.1683757142857177E-2</c:v>
                </c:pt>
                <c:pt idx="3">
                  <c:v>2.6649614285714322E-2</c:v>
                </c:pt>
                <c:pt idx="4">
                  <c:v>3.8340766666666658E-2</c:v>
                </c:pt>
                <c:pt idx="5">
                  <c:v>3.6883528571428612E-2</c:v>
                </c:pt>
                <c:pt idx="6">
                  <c:v>3.274792222222226E-2</c:v>
                </c:pt>
                <c:pt idx="7">
                  <c:v>2.9412573913043482E-2</c:v>
                </c:pt>
                <c:pt idx="8">
                  <c:v>2.4535653333333338E-2</c:v>
                </c:pt>
                <c:pt idx="9">
                  <c:v>2.2308586363636335E-2</c:v>
                </c:pt>
                <c:pt idx="10">
                  <c:v>2.0744278260869598E-2</c:v>
                </c:pt>
                <c:pt idx="11">
                  <c:v>2.7641604347826105E-2</c:v>
                </c:pt>
                <c:pt idx="12">
                  <c:v>2.8748635714285709E-2</c:v>
                </c:pt>
                <c:pt idx="13">
                  <c:v>1.7389557692307718E-2</c:v>
                </c:pt>
                <c:pt idx="14">
                  <c:v>8.6616690909091052E-3</c:v>
                </c:pt>
                <c:pt idx="15">
                  <c:v>1.3929741176470584E-2</c:v>
                </c:pt>
                <c:pt idx="16">
                  <c:v>1.5568889473684221E-2</c:v>
                </c:pt>
                <c:pt idx="17">
                  <c:v>-1.9617862068965538E-2</c:v>
                </c:pt>
                <c:pt idx="18">
                  <c:v>-3.0654957142857146E-2</c:v>
                </c:pt>
                <c:pt idx="19">
                  <c:v>-3.9855699999999994E-2</c:v>
                </c:pt>
                <c:pt idx="20">
                  <c:v>-9.3535738461538523E-2</c:v>
                </c:pt>
                <c:pt idx="21">
                  <c:v>-0.10808633333333341</c:v>
                </c:pt>
                <c:pt idx="22">
                  <c:v>-0.10538211111111112</c:v>
                </c:pt>
                <c:pt idx="23">
                  <c:v>-8.8923314285714303E-2</c:v>
                </c:pt>
                <c:pt idx="24">
                  <c:v>-8.1916060000000027E-2</c:v>
                </c:pt>
              </c:numCache>
            </c:numRef>
          </c:xVal>
          <c:yVal>
            <c:numRef>
              <c:f>xpca20x25!$F$163:$F$187</c:f>
              <c:numCache>
                <c:formatCode>General</c:formatCode>
                <c:ptCount val="25"/>
                <c:pt idx="7">
                  <c:v>-1.6336334782608713E-4</c:v>
                </c:pt>
                <c:pt idx="8">
                  <c:v>-2.0407433333333332E-2</c:v>
                </c:pt>
                <c:pt idx="9">
                  <c:v>-3.4458454545454542E-2</c:v>
                </c:pt>
                <c:pt idx="16">
                  <c:v>-7.1736923157894844E-4</c:v>
                </c:pt>
                <c:pt idx="17">
                  <c:v>1.1687477931034487E-2</c:v>
                </c:pt>
                <c:pt idx="19">
                  <c:v>1.0222907142857153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E57-4E88-AF58-C12A225ADD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677888"/>
        <c:axId val="96680192"/>
      </c:scatterChart>
      <c:valAx>
        <c:axId val="96677888"/>
        <c:scaling>
          <c:orientation val="minMax"/>
          <c:max val="6.0000000000000032E-2"/>
          <c:min val="-0.1200000000000000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680192"/>
        <c:crossesAt val="-0.18000000000000016"/>
        <c:crossBetween val="midCat"/>
      </c:valAx>
      <c:valAx>
        <c:axId val="96680192"/>
        <c:scaling>
          <c:orientation val="minMax"/>
          <c:max val="0.1"/>
          <c:min val="-0.18000000000000016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nl-NL" sz="1400" b="1"/>
                  <a:t>PC4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677888"/>
        <c:crossesAt val="-0.12000000000000002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6098714B-570C-4CA9-B73B-27C4896BEACC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  <a:endParaRPr lang="es-ES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EE2182D8-1042-413F-B8A3-C56FEC2C80D8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22954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nl-NL" smtClean="0"/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4B8D0D60-A69D-4592-AF3B-CEA6D5429015}" type="slidenum">
              <a:rPr lang="nl-NL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nl-NL">
              <a:cs typeface="Arial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7A2D93-39DD-4CDC-9678-0B5AA57F08A5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5B8768-4B8C-4199-951B-3DE799A16712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2B1A5E-6331-4C5E-8AA6-0EB8741EC6F4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4CE35D-128B-4038-AE55-B1F7F887F16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0C2225-120D-4886-86BC-B58A86812FAC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7F3125-34B3-4393-8E76-E2B0EEEC586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CD3A51-D6DB-4137-BE38-DC36A66EDC1B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2B57B5-1C9A-4558-B12E-F558BF75FBE4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0F6C01-A672-473E-BCD7-E547FF36D92F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F84F00-343E-4334-9B82-DAF48EDC290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B08CA8-30A3-40E2-A6BE-159BF9FB14AA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9BDDBF-7D1D-4FAE-A2AE-56123E04D5D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2C0C49-69E9-4539-9963-7AE1231BE115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0B3993-B22D-4335-8235-8462E9A46CE2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6E8118-0EC4-4049-BE6C-7189401DA7A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754CF9-2626-4701-A80D-CCF1F23E1088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209408-63D6-4DB6-B4EA-47AF0EF1F4A9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7A2899-068F-46A2-81F3-5EC6761D0A0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45010E-DB10-4316-B2D2-69649E7AD4CF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709E31-6F5E-42D2-8D33-B7AA6684F8CA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es-E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4FF3DB-86C2-4974-ACBC-2A8945A9B6BD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8F6DC5-F3DD-46FB-A716-A1C8F1093EE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título mestre</a:t>
            </a:r>
            <a:endParaRPr lang="es-E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s-E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B28537F-1D28-4BFF-94F0-B6FDAED1099A}" type="datetimeFigureOut">
              <a:rPr lang="es-ES"/>
              <a:pPr>
                <a:defRPr/>
              </a:pPr>
              <a:t>06/07/2018</a:t>
            </a:fld>
            <a:endParaRPr lang="es-E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587AB01-B5C3-4FCB-AD79-04D92228C93D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5" name="Chart 64">
            <a:extLst>
              <a:ext uri="{FF2B5EF4-FFF2-40B4-BE49-F238E27FC236}"/>
            </a:extLst>
          </p:cNvPr>
          <p:cNvGraphicFramePr>
            <a:graphicFrameLocks/>
          </p:cNvGraphicFramePr>
          <p:nvPr/>
        </p:nvGraphicFramePr>
        <p:xfrm>
          <a:off x="44489" y="1983790"/>
          <a:ext cx="3143250" cy="2886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7" name="Chart 66">
            <a:extLst>
              <a:ext uri="{FF2B5EF4-FFF2-40B4-BE49-F238E27FC236}"/>
            </a:extLst>
          </p:cNvPr>
          <p:cNvGraphicFramePr>
            <a:graphicFrameLocks/>
          </p:cNvGraphicFramePr>
          <p:nvPr/>
        </p:nvGraphicFramePr>
        <p:xfrm>
          <a:off x="3114666" y="1985962"/>
          <a:ext cx="3143250" cy="2886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8" name="Chart 67">
            <a:extLst>
              <a:ext uri="{FF2B5EF4-FFF2-40B4-BE49-F238E27FC236}"/>
            </a:extLst>
          </p:cNvPr>
          <p:cNvGraphicFramePr>
            <a:graphicFrameLocks/>
          </p:cNvGraphicFramePr>
          <p:nvPr/>
        </p:nvGraphicFramePr>
        <p:xfrm>
          <a:off x="6143062" y="1983790"/>
          <a:ext cx="3143250" cy="2886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340" name="Rectangle 3"/>
          <p:cNvSpPr>
            <a:spLocks noChangeArrowheads="1"/>
          </p:cNvSpPr>
          <p:nvPr/>
        </p:nvSpPr>
        <p:spPr bwMode="auto">
          <a:xfrm>
            <a:off x="2401888" y="2198688"/>
            <a:ext cx="2952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ICL</a:t>
            </a:r>
          </a:p>
        </p:txBody>
      </p:sp>
      <p:sp>
        <p:nvSpPr>
          <p:cNvPr id="14341" name="Rectangle 4"/>
          <p:cNvSpPr>
            <a:spLocks noChangeArrowheads="1"/>
          </p:cNvSpPr>
          <p:nvPr/>
        </p:nvSpPr>
        <p:spPr bwMode="auto">
          <a:xfrm>
            <a:off x="2295525" y="3024188"/>
            <a:ext cx="3095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FIN</a:t>
            </a:r>
          </a:p>
        </p:txBody>
      </p:sp>
      <p:sp>
        <p:nvSpPr>
          <p:cNvPr id="14342" name="Rectangle 5"/>
          <p:cNvSpPr>
            <a:spLocks noChangeArrowheads="1"/>
          </p:cNvSpPr>
          <p:nvPr/>
        </p:nvSpPr>
        <p:spPr bwMode="auto">
          <a:xfrm>
            <a:off x="5645150" y="3560763"/>
            <a:ext cx="3286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KL</a:t>
            </a:r>
          </a:p>
        </p:txBody>
      </p:sp>
      <p:sp>
        <p:nvSpPr>
          <p:cNvPr id="14343" name="Rectangle 6"/>
          <p:cNvSpPr>
            <a:spLocks noChangeArrowheads="1"/>
          </p:cNvSpPr>
          <p:nvPr/>
        </p:nvSpPr>
        <p:spPr bwMode="auto">
          <a:xfrm>
            <a:off x="2249488" y="3282950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UL</a:t>
            </a:r>
          </a:p>
        </p:txBody>
      </p:sp>
      <p:sp>
        <p:nvSpPr>
          <p:cNvPr id="14344" name="Rectangle 7"/>
          <p:cNvSpPr>
            <a:spLocks noChangeArrowheads="1"/>
          </p:cNvSpPr>
          <p:nvPr/>
        </p:nvSpPr>
        <p:spPr bwMode="auto">
          <a:xfrm>
            <a:off x="2662238" y="3363913"/>
            <a:ext cx="3619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UL</a:t>
            </a:r>
          </a:p>
        </p:txBody>
      </p:sp>
      <p:sp>
        <p:nvSpPr>
          <p:cNvPr id="14345" name="Rectangle 25"/>
          <p:cNvSpPr>
            <a:spLocks noChangeArrowheads="1"/>
          </p:cNvSpPr>
          <p:nvPr/>
        </p:nvSpPr>
        <p:spPr bwMode="auto">
          <a:xfrm>
            <a:off x="2514600" y="3275013"/>
            <a:ext cx="3413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RR</a:t>
            </a:r>
          </a:p>
        </p:txBody>
      </p:sp>
      <p:sp>
        <p:nvSpPr>
          <p:cNvPr id="14346" name="Rectangle 26"/>
          <p:cNvSpPr>
            <a:spLocks noChangeArrowheads="1"/>
          </p:cNvSpPr>
          <p:nvPr/>
        </p:nvSpPr>
        <p:spPr bwMode="auto">
          <a:xfrm>
            <a:off x="2333625" y="3425825"/>
            <a:ext cx="3333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BLB</a:t>
            </a:r>
          </a:p>
        </p:txBody>
      </p:sp>
      <p:sp>
        <p:nvSpPr>
          <p:cNvPr id="14347" name="Rectangle 27"/>
          <p:cNvSpPr>
            <a:spLocks noChangeArrowheads="1"/>
          </p:cNvSpPr>
          <p:nvPr/>
        </p:nvSpPr>
        <p:spPr bwMode="auto">
          <a:xfrm>
            <a:off x="2540000" y="3579813"/>
            <a:ext cx="3429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FSS </a:t>
            </a:r>
          </a:p>
        </p:txBody>
      </p:sp>
      <p:sp>
        <p:nvSpPr>
          <p:cNvPr id="14348" name="Rectangle 28"/>
          <p:cNvSpPr>
            <a:spLocks noChangeArrowheads="1"/>
          </p:cNvSpPr>
          <p:nvPr/>
        </p:nvSpPr>
        <p:spPr bwMode="auto">
          <a:xfrm>
            <a:off x="2249488" y="3598863"/>
            <a:ext cx="3508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CCG</a:t>
            </a:r>
          </a:p>
        </p:txBody>
      </p:sp>
      <p:sp>
        <p:nvSpPr>
          <p:cNvPr id="14349" name="Rectangle 29"/>
          <p:cNvSpPr>
            <a:spLocks noChangeArrowheads="1"/>
          </p:cNvSpPr>
          <p:nvPr/>
        </p:nvSpPr>
        <p:spPr bwMode="auto">
          <a:xfrm>
            <a:off x="2185988" y="3743325"/>
            <a:ext cx="3397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ASP</a:t>
            </a:r>
          </a:p>
        </p:txBody>
      </p:sp>
      <p:sp>
        <p:nvSpPr>
          <p:cNvPr id="14350" name="Rectangle 30"/>
          <p:cNvSpPr>
            <a:spLocks noChangeArrowheads="1"/>
          </p:cNvSpPr>
          <p:nvPr/>
        </p:nvSpPr>
        <p:spPr bwMode="auto">
          <a:xfrm>
            <a:off x="2152650" y="3676650"/>
            <a:ext cx="3619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ARG</a:t>
            </a:r>
          </a:p>
        </p:txBody>
      </p:sp>
      <p:sp>
        <p:nvSpPr>
          <p:cNvPr id="14351" name="Rectangle 95"/>
          <p:cNvSpPr>
            <a:spLocks noChangeArrowheads="1"/>
          </p:cNvSpPr>
          <p:nvPr/>
        </p:nvSpPr>
        <p:spPr bwMode="auto">
          <a:xfrm>
            <a:off x="8493125" y="3414713"/>
            <a:ext cx="3571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GGT</a:t>
            </a:r>
          </a:p>
        </p:txBody>
      </p:sp>
      <p:sp>
        <p:nvSpPr>
          <p:cNvPr id="14352" name="Rectangle 96"/>
          <p:cNvSpPr>
            <a:spLocks noChangeArrowheads="1"/>
          </p:cNvSpPr>
          <p:nvPr/>
        </p:nvSpPr>
        <p:spPr bwMode="auto">
          <a:xfrm>
            <a:off x="2551113" y="3727450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CRS</a:t>
            </a:r>
          </a:p>
        </p:txBody>
      </p:sp>
      <p:sp>
        <p:nvSpPr>
          <p:cNvPr id="14353" name="Rectangle 34"/>
          <p:cNvSpPr>
            <a:spLocks noChangeArrowheads="1"/>
          </p:cNvSpPr>
          <p:nvPr/>
        </p:nvSpPr>
        <p:spPr bwMode="auto">
          <a:xfrm>
            <a:off x="2365375" y="3892550"/>
            <a:ext cx="3444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SAR</a:t>
            </a:r>
          </a:p>
        </p:txBody>
      </p:sp>
      <p:sp>
        <p:nvSpPr>
          <p:cNvPr id="14354" name="Rectangle 97"/>
          <p:cNvSpPr>
            <a:spLocks noChangeArrowheads="1"/>
          </p:cNvSpPr>
          <p:nvPr/>
        </p:nvSpPr>
        <p:spPr bwMode="auto">
          <a:xfrm>
            <a:off x="2001838" y="3821113"/>
            <a:ext cx="3556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LS</a:t>
            </a:r>
          </a:p>
        </p:txBody>
      </p:sp>
      <p:sp>
        <p:nvSpPr>
          <p:cNvPr id="14355" name="Rectangle 98"/>
          <p:cNvSpPr>
            <a:spLocks noChangeArrowheads="1"/>
          </p:cNvSpPr>
          <p:nvPr/>
        </p:nvSpPr>
        <p:spPr bwMode="auto">
          <a:xfrm>
            <a:off x="2090738" y="3938588"/>
            <a:ext cx="3683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AL</a:t>
            </a:r>
          </a:p>
        </p:txBody>
      </p:sp>
      <p:sp>
        <p:nvSpPr>
          <p:cNvPr id="14356" name="Rectangle 99"/>
          <p:cNvSpPr>
            <a:spLocks noChangeArrowheads="1"/>
          </p:cNvSpPr>
          <p:nvPr/>
        </p:nvSpPr>
        <p:spPr bwMode="auto">
          <a:xfrm>
            <a:off x="2322513" y="3960813"/>
            <a:ext cx="3444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RAS</a:t>
            </a:r>
          </a:p>
        </p:txBody>
      </p:sp>
      <p:sp>
        <p:nvSpPr>
          <p:cNvPr id="14357" name="Rectangle 100"/>
          <p:cNvSpPr>
            <a:spLocks noChangeArrowheads="1"/>
          </p:cNvSpPr>
          <p:nvPr/>
        </p:nvSpPr>
        <p:spPr bwMode="auto">
          <a:xfrm>
            <a:off x="1604963" y="3917950"/>
            <a:ext cx="3905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OR</a:t>
            </a:r>
          </a:p>
        </p:txBody>
      </p:sp>
      <p:sp>
        <p:nvSpPr>
          <p:cNvPr id="14358" name="Rectangle 101"/>
          <p:cNvSpPr>
            <a:spLocks noChangeArrowheads="1"/>
          </p:cNvSpPr>
          <p:nvPr/>
        </p:nvSpPr>
        <p:spPr bwMode="auto">
          <a:xfrm>
            <a:off x="1506538" y="4243388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PAL</a:t>
            </a:r>
          </a:p>
        </p:txBody>
      </p:sp>
      <p:sp>
        <p:nvSpPr>
          <p:cNvPr id="14359" name="Rectangle 102"/>
          <p:cNvSpPr>
            <a:spLocks noChangeArrowheads="1"/>
          </p:cNvSpPr>
          <p:nvPr/>
        </p:nvSpPr>
        <p:spPr bwMode="auto">
          <a:xfrm>
            <a:off x="1352550" y="3646488"/>
            <a:ext cx="3698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TB</a:t>
            </a:r>
          </a:p>
        </p:txBody>
      </p:sp>
      <p:sp>
        <p:nvSpPr>
          <p:cNvPr id="14360" name="Rectangle 103"/>
          <p:cNvSpPr>
            <a:spLocks noChangeArrowheads="1"/>
          </p:cNvSpPr>
          <p:nvPr/>
        </p:nvSpPr>
        <p:spPr bwMode="auto">
          <a:xfrm>
            <a:off x="811213" y="3497263"/>
            <a:ext cx="3317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DIA</a:t>
            </a:r>
          </a:p>
        </p:txBody>
      </p:sp>
      <p:sp>
        <p:nvSpPr>
          <p:cNvPr id="14361" name="Rectangle 104"/>
          <p:cNvSpPr>
            <a:spLocks noChangeArrowheads="1"/>
          </p:cNvSpPr>
          <p:nvPr/>
        </p:nvSpPr>
        <p:spPr bwMode="auto">
          <a:xfrm>
            <a:off x="620713" y="3417888"/>
            <a:ext cx="34131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F</a:t>
            </a:r>
          </a:p>
        </p:txBody>
      </p:sp>
      <p:sp>
        <p:nvSpPr>
          <p:cNvPr id="14362" name="Rectangle 105"/>
          <p:cNvSpPr>
            <a:spLocks noChangeArrowheads="1"/>
          </p:cNvSpPr>
          <p:nvPr/>
        </p:nvSpPr>
        <p:spPr bwMode="auto">
          <a:xfrm>
            <a:off x="658813" y="3205163"/>
            <a:ext cx="37941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EN</a:t>
            </a:r>
          </a:p>
        </p:txBody>
      </p:sp>
      <p:sp>
        <p:nvSpPr>
          <p:cNvPr id="14363" name="Rectangle 106"/>
          <p:cNvSpPr>
            <a:spLocks noChangeArrowheads="1"/>
          </p:cNvSpPr>
          <p:nvPr/>
        </p:nvSpPr>
        <p:spPr bwMode="auto">
          <a:xfrm>
            <a:off x="6965950" y="2949575"/>
            <a:ext cx="3587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U</a:t>
            </a:r>
          </a:p>
        </p:txBody>
      </p:sp>
      <p:sp>
        <p:nvSpPr>
          <p:cNvPr id="14364" name="Rectangle 107"/>
          <p:cNvSpPr>
            <a:spLocks noChangeArrowheads="1"/>
          </p:cNvSpPr>
          <p:nvPr/>
        </p:nvSpPr>
        <p:spPr bwMode="auto">
          <a:xfrm>
            <a:off x="1108075" y="3398838"/>
            <a:ext cx="3683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ND</a:t>
            </a:r>
          </a:p>
        </p:txBody>
      </p:sp>
      <p:sp>
        <p:nvSpPr>
          <p:cNvPr id="14365" name="Rectangle 46"/>
          <p:cNvSpPr>
            <a:spLocks noChangeArrowheads="1"/>
          </p:cNvSpPr>
          <p:nvPr/>
        </p:nvSpPr>
        <p:spPr bwMode="auto">
          <a:xfrm>
            <a:off x="5470525" y="2379663"/>
            <a:ext cx="2952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ICL</a:t>
            </a:r>
          </a:p>
        </p:txBody>
      </p:sp>
      <p:sp>
        <p:nvSpPr>
          <p:cNvPr id="14366" name="Rectangle 47"/>
          <p:cNvSpPr>
            <a:spLocks noChangeArrowheads="1"/>
          </p:cNvSpPr>
          <p:nvPr/>
        </p:nvSpPr>
        <p:spPr bwMode="auto">
          <a:xfrm>
            <a:off x="8715375" y="4276725"/>
            <a:ext cx="2952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ICL</a:t>
            </a:r>
          </a:p>
        </p:txBody>
      </p:sp>
      <p:sp>
        <p:nvSpPr>
          <p:cNvPr id="14367" name="Rectangle 48"/>
          <p:cNvSpPr>
            <a:spLocks noChangeArrowheads="1"/>
          </p:cNvSpPr>
          <p:nvPr/>
        </p:nvSpPr>
        <p:spPr bwMode="auto">
          <a:xfrm>
            <a:off x="5483225" y="3302000"/>
            <a:ext cx="3095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FIN</a:t>
            </a:r>
          </a:p>
        </p:txBody>
      </p:sp>
      <p:sp>
        <p:nvSpPr>
          <p:cNvPr id="14368" name="Rectangle 49"/>
          <p:cNvSpPr>
            <a:spLocks noChangeArrowheads="1"/>
          </p:cNvSpPr>
          <p:nvPr/>
        </p:nvSpPr>
        <p:spPr bwMode="auto">
          <a:xfrm>
            <a:off x="8615363" y="2635250"/>
            <a:ext cx="30956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FIN</a:t>
            </a:r>
          </a:p>
        </p:txBody>
      </p:sp>
      <p:sp>
        <p:nvSpPr>
          <p:cNvPr id="14369" name="Rectangle 50"/>
          <p:cNvSpPr>
            <a:spLocks noChangeArrowheads="1"/>
          </p:cNvSpPr>
          <p:nvPr/>
        </p:nvSpPr>
        <p:spPr bwMode="auto">
          <a:xfrm>
            <a:off x="2592388" y="3124200"/>
            <a:ext cx="32861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KL</a:t>
            </a:r>
          </a:p>
        </p:txBody>
      </p:sp>
      <p:sp>
        <p:nvSpPr>
          <p:cNvPr id="14370" name="Rectangle 51"/>
          <p:cNvSpPr>
            <a:spLocks noChangeArrowheads="1"/>
          </p:cNvSpPr>
          <p:nvPr/>
        </p:nvSpPr>
        <p:spPr bwMode="auto">
          <a:xfrm>
            <a:off x="8670925" y="2006600"/>
            <a:ext cx="3286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KL</a:t>
            </a:r>
          </a:p>
        </p:txBody>
      </p:sp>
      <p:sp>
        <p:nvSpPr>
          <p:cNvPr id="14371" name="Rectangle 52"/>
          <p:cNvSpPr>
            <a:spLocks noChangeArrowheads="1"/>
          </p:cNvSpPr>
          <p:nvPr/>
        </p:nvSpPr>
        <p:spPr bwMode="auto">
          <a:xfrm>
            <a:off x="5588000" y="3487738"/>
            <a:ext cx="3397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UL</a:t>
            </a:r>
          </a:p>
        </p:txBody>
      </p:sp>
      <p:sp>
        <p:nvSpPr>
          <p:cNvPr id="14372" name="Rectangle 53"/>
          <p:cNvSpPr>
            <a:spLocks noChangeArrowheads="1"/>
          </p:cNvSpPr>
          <p:nvPr/>
        </p:nvSpPr>
        <p:spPr bwMode="auto">
          <a:xfrm>
            <a:off x="8332788" y="2593975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0000FF"/>
                </a:solidFill>
                <a:latin typeface="Calibri" pitchFamily="34" charset="0"/>
              </a:rPr>
              <a:t>DUL</a:t>
            </a:r>
          </a:p>
        </p:txBody>
      </p:sp>
      <p:sp>
        <p:nvSpPr>
          <p:cNvPr id="14373" name="Rectangle 54"/>
          <p:cNvSpPr>
            <a:spLocks noChangeArrowheads="1"/>
          </p:cNvSpPr>
          <p:nvPr/>
        </p:nvSpPr>
        <p:spPr bwMode="auto">
          <a:xfrm>
            <a:off x="5618163" y="3917950"/>
            <a:ext cx="36036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UL</a:t>
            </a:r>
          </a:p>
        </p:txBody>
      </p:sp>
      <p:sp>
        <p:nvSpPr>
          <p:cNvPr id="14374" name="Rectangle 55"/>
          <p:cNvSpPr>
            <a:spLocks noChangeArrowheads="1"/>
          </p:cNvSpPr>
          <p:nvPr/>
        </p:nvSpPr>
        <p:spPr bwMode="auto">
          <a:xfrm>
            <a:off x="8751888" y="2773363"/>
            <a:ext cx="36036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UL</a:t>
            </a:r>
          </a:p>
        </p:txBody>
      </p:sp>
      <p:sp>
        <p:nvSpPr>
          <p:cNvPr id="14375" name="Rectangle 57"/>
          <p:cNvSpPr>
            <a:spLocks noChangeArrowheads="1"/>
          </p:cNvSpPr>
          <p:nvPr/>
        </p:nvSpPr>
        <p:spPr bwMode="auto">
          <a:xfrm>
            <a:off x="5724525" y="3784600"/>
            <a:ext cx="3429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RR</a:t>
            </a:r>
          </a:p>
        </p:txBody>
      </p:sp>
      <p:sp>
        <p:nvSpPr>
          <p:cNvPr id="14376" name="Rectangle 58"/>
          <p:cNvSpPr>
            <a:spLocks noChangeArrowheads="1"/>
          </p:cNvSpPr>
          <p:nvPr/>
        </p:nvSpPr>
        <p:spPr bwMode="auto">
          <a:xfrm>
            <a:off x="8696325" y="2906713"/>
            <a:ext cx="3413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RR</a:t>
            </a:r>
          </a:p>
        </p:txBody>
      </p:sp>
      <p:sp>
        <p:nvSpPr>
          <p:cNvPr id="14377" name="Rectangle 59"/>
          <p:cNvSpPr>
            <a:spLocks noChangeArrowheads="1"/>
          </p:cNvSpPr>
          <p:nvPr/>
        </p:nvSpPr>
        <p:spPr bwMode="auto">
          <a:xfrm>
            <a:off x="5670550" y="3716338"/>
            <a:ext cx="3333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BLB</a:t>
            </a:r>
          </a:p>
        </p:txBody>
      </p:sp>
      <p:sp>
        <p:nvSpPr>
          <p:cNvPr id="14378" name="Rectangle 60"/>
          <p:cNvSpPr>
            <a:spLocks noChangeArrowheads="1"/>
          </p:cNvSpPr>
          <p:nvPr/>
        </p:nvSpPr>
        <p:spPr bwMode="auto">
          <a:xfrm>
            <a:off x="5627688" y="3636963"/>
            <a:ext cx="3429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FSS </a:t>
            </a:r>
          </a:p>
        </p:txBody>
      </p:sp>
      <p:sp>
        <p:nvSpPr>
          <p:cNvPr id="14379" name="Rectangle 61"/>
          <p:cNvSpPr>
            <a:spLocks noChangeArrowheads="1"/>
          </p:cNvSpPr>
          <p:nvPr/>
        </p:nvSpPr>
        <p:spPr bwMode="auto">
          <a:xfrm>
            <a:off x="8439150" y="2751138"/>
            <a:ext cx="3429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FSS </a:t>
            </a:r>
          </a:p>
        </p:txBody>
      </p:sp>
      <p:sp>
        <p:nvSpPr>
          <p:cNvPr id="14380" name="Rectangle 62"/>
          <p:cNvSpPr>
            <a:spLocks noChangeArrowheads="1"/>
          </p:cNvSpPr>
          <p:nvPr/>
        </p:nvSpPr>
        <p:spPr bwMode="auto">
          <a:xfrm>
            <a:off x="4668838" y="3098800"/>
            <a:ext cx="3889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OR</a:t>
            </a:r>
          </a:p>
        </p:txBody>
      </p:sp>
      <p:sp>
        <p:nvSpPr>
          <p:cNvPr id="14381" name="Rectangle 63"/>
          <p:cNvSpPr>
            <a:spLocks noChangeArrowheads="1"/>
          </p:cNvSpPr>
          <p:nvPr/>
        </p:nvSpPr>
        <p:spPr bwMode="auto">
          <a:xfrm>
            <a:off x="7854950" y="2614613"/>
            <a:ext cx="3905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OR</a:t>
            </a:r>
          </a:p>
        </p:txBody>
      </p:sp>
      <p:sp>
        <p:nvSpPr>
          <p:cNvPr id="14382" name="Rectangle 68"/>
          <p:cNvSpPr>
            <a:spLocks noChangeArrowheads="1"/>
          </p:cNvSpPr>
          <p:nvPr/>
        </p:nvSpPr>
        <p:spPr bwMode="auto">
          <a:xfrm>
            <a:off x="8615363" y="2706688"/>
            <a:ext cx="33496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BLB</a:t>
            </a:r>
          </a:p>
        </p:txBody>
      </p:sp>
      <p:sp>
        <p:nvSpPr>
          <p:cNvPr id="14383" name="Rectangle 69"/>
          <p:cNvSpPr>
            <a:spLocks noChangeArrowheads="1"/>
          </p:cNvSpPr>
          <p:nvPr/>
        </p:nvSpPr>
        <p:spPr bwMode="auto">
          <a:xfrm>
            <a:off x="4576763" y="2252663"/>
            <a:ext cx="3365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PAL</a:t>
            </a:r>
          </a:p>
        </p:txBody>
      </p:sp>
      <p:sp>
        <p:nvSpPr>
          <p:cNvPr id="14384" name="Rectangle 70"/>
          <p:cNvSpPr>
            <a:spLocks noChangeArrowheads="1"/>
          </p:cNvSpPr>
          <p:nvPr/>
        </p:nvSpPr>
        <p:spPr bwMode="auto">
          <a:xfrm>
            <a:off x="7594600" y="2392363"/>
            <a:ext cx="33813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PAL</a:t>
            </a:r>
          </a:p>
        </p:txBody>
      </p:sp>
      <p:sp>
        <p:nvSpPr>
          <p:cNvPr id="14385" name="Rectangle 71"/>
          <p:cNvSpPr>
            <a:spLocks noChangeArrowheads="1"/>
          </p:cNvSpPr>
          <p:nvPr/>
        </p:nvSpPr>
        <p:spPr bwMode="auto">
          <a:xfrm>
            <a:off x="4414838" y="3298825"/>
            <a:ext cx="3714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TB</a:t>
            </a:r>
          </a:p>
        </p:txBody>
      </p:sp>
      <p:sp>
        <p:nvSpPr>
          <p:cNvPr id="14386" name="Rectangle 72"/>
          <p:cNvSpPr>
            <a:spLocks noChangeArrowheads="1"/>
          </p:cNvSpPr>
          <p:nvPr/>
        </p:nvSpPr>
        <p:spPr bwMode="auto">
          <a:xfrm>
            <a:off x="7424738" y="2725738"/>
            <a:ext cx="3714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MTB</a:t>
            </a:r>
          </a:p>
        </p:txBody>
      </p:sp>
      <p:sp>
        <p:nvSpPr>
          <p:cNvPr id="14387" name="Rectangle 73"/>
          <p:cNvSpPr>
            <a:spLocks noChangeArrowheads="1"/>
          </p:cNvSpPr>
          <p:nvPr/>
        </p:nvSpPr>
        <p:spPr bwMode="auto">
          <a:xfrm>
            <a:off x="5154613" y="3471863"/>
            <a:ext cx="3444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RAS</a:t>
            </a:r>
          </a:p>
        </p:txBody>
      </p:sp>
      <p:sp>
        <p:nvSpPr>
          <p:cNvPr id="14388" name="Rectangle 74"/>
          <p:cNvSpPr>
            <a:spLocks noChangeArrowheads="1"/>
          </p:cNvSpPr>
          <p:nvPr/>
        </p:nvSpPr>
        <p:spPr bwMode="auto">
          <a:xfrm>
            <a:off x="8199438" y="2854325"/>
            <a:ext cx="3444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RAS</a:t>
            </a:r>
          </a:p>
        </p:txBody>
      </p:sp>
      <p:sp>
        <p:nvSpPr>
          <p:cNvPr id="14389" name="Rectangle 75"/>
          <p:cNvSpPr>
            <a:spLocks noChangeArrowheads="1"/>
          </p:cNvSpPr>
          <p:nvPr/>
        </p:nvSpPr>
        <p:spPr bwMode="auto">
          <a:xfrm>
            <a:off x="5226050" y="3751263"/>
            <a:ext cx="35083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CCG</a:t>
            </a:r>
          </a:p>
        </p:txBody>
      </p:sp>
      <p:sp>
        <p:nvSpPr>
          <p:cNvPr id="14390" name="Rectangle 76"/>
          <p:cNvSpPr>
            <a:spLocks noChangeArrowheads="1"/>
          </p:cNvSpPr>
          <p:nvPr/>
        </p:nvSpPr>
        <p:spPr bwMode="auto">
          <a:xfrm>
            <a:off x="8480425" y="2898775"/>
            <a:ext cx="35083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CCG</a:t>
            </a:r>
          </a:p>
        </p:txBody>
      </p:sp>
      <p:sp>
        <p:nvSpPr>
          <p:cNvPr id="14391" name="Rectangle 77"/>
          <p:cNvSpPr>
            <a:spLocks noChangeArrowheads="1"/>
          </p:cNvSpPr>
          <p:nvPr/>
        </p:nvSpPr>
        <p:spPr bwMode="auto">
          <a:xfrm>
            <a:off x="5294313" y="3848100"/>
            <a:ext cx="3397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ASP</a:t>
            </a:r>
          </a:p>
        </p:txBody>
      </p:sp>
      <p:sp>
        <p:nvSpPr>
          <p:cNvPr id="14392" name="Rectangle 78"/>
          <p:cNvSpPr>
            <a:spLocks noChangeArrowheads="1"/>
          </p:cNvSpPr>
          <p:nvPr/>
        </p:nvSpPr>
        <p:spPr bwMode="auto">
          <a:xfrm>
            <a:off x="8531225" y="3108325"/>
            <a:ext cx="3413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3399FF"/>
                </a:solidFill>
                <a:latin typeface="Calibri" pitchFamily="34" charset="0"/>
              </a:rPr>
              <a:t>ASP</a:t>
            </a:r>
          </a:p>
        </p:txBody>
      </p:sp>
      <p:sp>
        <p:nvSpPr>
          <p:cNvPr id="14393" name="Rectangle 79"/>
          <p:cNvSpPr>
            <a:spLocks noChangeArrowheads="1"/>
          </p:cNvSpPr>
          <p:nvPr/>
        </p:nvSpPr>
        <p:spPr bwMode="auto">
          <a:xfrm>
            <a:off x="5205413" y="3676650"/>
            <a:ext cx="3619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ARG</a:t>
            </a:r>
          </a:p>
        </p:txBody>
      </p:sp>
      <p:sp>
        <p:nvSpPr>
          <p:cNvPr id="14394" name="Rectangle 80"/>
          <p:cNvSpPr>
            <a:spLocks noChangeArrowheads="1"/>
          </p:cNvSpPr>
          <p:nvPr/>
        </p:nvSpPr>
        <p:spPr bwMode="auto">
          <a:xfrm>
            <a:off x="5462588" y="4033838"/>
            <a:ext cx="3571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GGT</a:t>
            </a:r>
          </a:p>
        </p:txBody>
      </p:sp>
      <p:sp>
        <p:nvSpPr>
          <p:cNvPr id="14395" name="Rectangle 81"/>
          <p:cNvSpPr>
            <a:spLocks noChangeArrowheads="1"/>
          </p:cNvSpPr>
          <p:nvPr/>
        </p:nvSpPr>
        <p:spPr bwMode="auto">
          <a:xfrm>
            <a:off x="5475288" y="3862388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CRS</a:t>
            </a:r>
          </a:p>
        </p:txBody>
      </p:sp>
      <p:sp>
        <p:nvSpPr>
          <p:cNvPr id="14396" name="Rectangle 82"/>
          <p:cNvSpPr>
            <a:spLocks noChangeArrowheads="1"/>
          </p:cNvSpPr>
          <p:nvPr/>
        </p:nvSpPr>
        <p:spPr bwMode="auto">
          <a:xfrm>
            <a:off x="5349875" y="3544888"/>
            <a:ext cx="3444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SAR</a:t>
            </a:r>
          </a:p>
        </p:txBody>
      </p:sp>
      <p:sp>
        <p:nvSpPr>
          <p:cNvPr id="14397" name="Rectangle 83"/>
          <p:cNvSpPr>
            <a:spLocks noChangeArrowheads="1"/>
          </p:cNvSpPr>
          <p:nvPr/>
        </p:nvSpPr>
        <p:spPr bwMode="auto">
          <a:xfrm>
            <a:off x="5084763" y="3579813"/>
            <a:ext cx="3556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LS</a:t>
            </a:r>
          </a:p>
        </p:txBody>
      </p:sp>
      <p:sp>
        <p:nvSpPr>
          <p:cNvPr id="14398" name="Rectangle 84"/>
          <p:cNvSpPr>
            <a:spLocks noChangeArrowheads="1"/>
          </p:cNvSpPr>
          <p:nvPr/>
        </p:nvSpPr>
        <p:spPr bwMode="auto">
          <a:xfrm>
            <a:off x="8166100" y="2747963"/>
            <a:ext cx="3683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AL</a:t>
            </a:r>
          </a:p>
        </p:txBody>
      </p:sp>
      <p:sp>
        <p:nvSpPr>
          <p:cNvPr id="14399" name="Rectangle 85"/>
          <p:cNvSpPr>
            <a:spLocks noChangeArrowheads="1"/>
          </p:cNvSpPr>
          <p:nvPr/>
        </p:nvSpPr>
        <p:spPr bwMode="auto">
          <a:xfrm>
            <a:off x="6921500" y="2728913"/>
            <a:ext cx="3302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DIA</a:t>
            </a:r>
          </a:p>
        </p:txBody>
      </p:sp>
      <p:sp>
        <p:nvSpPr>
          <p:cNvPr id="14400" name="Rectangle 86"/>
          <p:cNvSpPr>
            <a:spLocks noChangeArrowheads="1"/>
          </p:cNvSpPr>
          <p:nvPr/>
        </p:nvSpPr>
        <p:spPr bwMode="auto">
          <a:xfrm>
            <a:off x="3717925" y="3717925"/>
            <a:ext cx="3413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F</a:t>
            </a:r>
          </a:p>
        </p:txBody>
      </p:sp>
      <p:sp>
        <p:nvSpPr>
          <p:cNvPr id="14401" name="Rectangle 87"/>
          <p:cNvSpPr>
            <a:spLocks noChangeArrowheads="1"/>
          </p:cNvSpPr>
          <p:nvPr/>
        </p:nvSpPr>
        <p:spPr bwMode="auto">
          <a:xfrm>
            <a:off x="3722688" y="3944938"/>
            <a:ext cx="379412" cy="201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EN</a:t>
            </a:r>
          </a:p>
        </p:txBody>
      </p:sp>
      <p:sp>
        <p:nvSpPr>
          <p:cNvPr id="14402" name="Rectangle 88"/>
          <p:cNvSpPr>
            <a:spLocks noChangeArrowheads="1"/>
          </p:cNvSpPr>
          <p:nvPr/>
        </p:nvSpPr>
        <p:spPr bwMode="auto">
          <a:xfrm>
            <a:off x="3940175" y="3860800"/>
            <a:ext cx="3603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U</a:t>
            </a:r>
          </a:p>
        </p:txBody>
      </p:sp>
      <p:sp>
        <p:nvSpPr>
          <p:cNvPr id="14403" name="Rectangle 89"/>
          <p:cNvSpPr>
            <a:spLocks noChangeArrowheads="1"/>
          </p:cNvSpPr>
          <p:nvPr/>
        </p:nvSpPr>
        <p:spPr bwMode="auto">
          <a:xfrm>
            <a:off x="4187825" y="3730625"/>
            <a:ext cx="3683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ND</a:t>
            </a:r>
          </a:p>
        </p:txBody>
      </p:sp>
      <p:sp>
        <p:nvSpPr>
          <p:cNvPr id="14404" name="Rectangle 90"/>
          <p:cNvSpPr>
            <a:spLocks noChangeArrowheads="1"/>
          </p:cNvSpPr>
          <p:nvPr/>
        </p:nvSpPr>
        <p:spPr bwMode="auto">
          <a:xfrm>
            <a:off x="8264525" y="3082925"/>
            <a:ext cx="36036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ARG</a:t>
            </a:r>
          </a:p>
        </p:txBody>
      </p:sp>
      <p:sp>
        <p:nvSpPr>
          <p:cNvPr id="14405" name="Rectangle 91"/>
          <p:cNvSpPr>
            <a:spLocks noChangeArrowheads="1"/>
          </p:cNvSpPr>
          <p:nvPr/>
        </p:nvSpPr>
        <p:spPr bwMode="auto">
          <a:xfrm>
            <a:off x="2533650" y="3827463"/>
            <a:ext cx="3571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GGT</a:t>
            </a:r>
          </a:p>
        </p:txBody>
      </p:sp>
      <p:sp>
        <p:nvSpPr>
          <p:cNvPr id="14406" name="Rectangle 92"/>
          <p:cNvSpPr>
            <a:spLocks noChangeArrowheads="1"/>
          </p:cNvSpPr>
          <p:nvPr/>
        </p:nvSpPr>
        <p:spPr bwMode="auto">
          <a:xfrm>
            <a:off x="8628063" y="2998788"/>
            <a:ext cx="33813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CRS</a:t>
            </a:r>
          </a:p>
        </p:txBody>
      </p:sp>
      <p:sp>
        <p:nvSpPr>
          <p:cNvPr id="14407" name="Rectangle 93"/>
          <p:cNvSpPr>
            <a:spLocks noChangeArrowheads="1"/>
          </p:cNvSpPr>
          <p:nvPr/>
        </p:nvSpPr>
        <p:spPr bwMode="auto">
          <a:xfrm>
            <a:off x="8221663" y="2933700"/>
            <a:ext cx="344487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SAR</a:t>
            </a:r>
          </a:p>
        </p:txBody>
      </p:sp>
      <p:sp>
        <p:nvSpPr>
          <p:cNvPr id="14408" name="Rectangle 94"/>
          <p:cNvSpPr>
            <a:spLocks noChangeArrowheads="1"/>
          </p:cNvSpPr>
          <p:nvPr/>
        </p:nvSpPr>
        <p:spPr bwMode="auto">
          <a:xfrm>
            <a:off x="8080375" y="3013075"/>
            <a:ext cx="35560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LS</a:t>
            </a:r>
          </a:p>
        </p:txBody>
      </p:sp>
      <p:sp>
        <p:nvSpPr>
          <p:cNvPr id="14409" name="Rectangle 108"/>
          <p:cNvSpPr>
            <a:spLocks noChangeArrowheads="1"/>
          </p:cNvSpPr>
          <p:nvPr/>
        </p:nvSpPr>
        <p:spPr bwMode="auto">
          <a:xfrm>
            <a:off x="5276850" y="3338513"/>
            <a:ext cx="3698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7C80"/>
                </a:solidFill>
                <a:latin typeface="Calibri" pitchFamily="34" charset="0"/>
              </a:rPr>
              <a:t>MAL</a:t>
            </a:r>
          </a:p>
        </p:txBody>
      </p:sp>
      <p:sp>
        <p:nvSpPr>
          <p:cNvPr id="14410" name="Rectangle 109"/>
          <p:cNvSpPr>
            <a:spLocks noChangeArrowheads="1"/>
          </p:cNvSpPr>
          <p:nvPr/>
        </p:nvSpPr>
        <p:spPr bwMode="auto">
          <a:xfrm>
            <a:off x="3898900" y="3595688"/>
            <a:ext cx="331788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DIA</a:t>
            </a:r>
          </a:p>
        </p:txBody>
      </p:sp>
      <p:sp>
        <p:nvSpPr>
          <p:cNvPr id="14411" name="Rectangle 110"/>
          <p:cNvSpPr>
            <a:spLocks noChangeArrowheads="1"/>
          </p:cNvSpPr>
          <p:nvPr/>
        </p:nvSpPr>
        <p:spPr bwMode="auto">
          <a:xfrm>
            <a:off x="6716713" y="2770188"/>
            <a:ext cx="341312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F</a:t>
            </a:r>
          </a:p>
        </p:txBody>
      </p:sp>
      <p:sp>
        <p:nvSpPr>
          <p:cNvPr id="14412" name="Rectangle 111"/>
          <p:cNvSpPr>
            <a:spLocks noChangeArrowheads="1"/>
          </p:cNvSpPr>
          <p:nvPr/>
        </p:nvSpPr>
        <p:spPr bwMode="auto">
          <a:xfrm>
            <a:off x="6750050" y="2997200"/>
            <a:ext cx="3794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MEN</a:t>
            </a:r>
          </a:p>
        </p:txBody>
      </p:sp>
      <p:sp>
        <p:nvSpPr>
          <p:cNvPr id="14413" name="Rectangle 112"/>
          <p:cNvSpPr>
            <a:spLocks noChangeArrowheads="1"/>
          </p:cNvSpPr>
          <p:nvPr/>
        </p:nvSpPr>
        <p:spPr bwMode="auto">
          <a:xfrm>
            <a:off x="892175" y="3263900"/>
            <a:ext cx="35877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SOU</a:t>
            </a:r>
          </a:p>
        </p:txBody>
      </p:sp>
      <p:sp>
        <p:nvSpPr>
          <p:cNvPr id="14414" name="Rectangle 114"/>
          <p:cNvSpPr>
            <a:spLocks noChangeArrowheads="1"/>
          </p:cNvSpPr>
          <p:nvPr/>
        </p:nvSpPr>
        <p:spPr bwMode="auto">
          <a:xfrm>
            <a:off x="7197725" y="2830513"/>
            <a:ext cx="366713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nl-NL" sz="700" b="1">
                <a:solidFill>
                  <a:srgbClr val="FF0000"/>
                </a:solidFill>
                <a:latin typeface="Calibri" pitchFamily="34" charset="0"/>
              </a:rPr>
              <a:t>AND</a:t>
            </a:r>
          </a:p>
        </p:txBody>
      </p:sp>
      <p:sp>
        <p:nvSpPr>
          <p:cNvPr id="14415" name="113 Rectángulo"/>
          <p:cNvSpPr>
            <a:spLocks noChangeArrowheads="1"/>
          </p:cNvSpPr>
          <p:nvPr/>
        </p:nvSpPr>
        <p:spPr bwMode="auto">
          <a:xfrm>
            <a:off x="179388" y="260350"/>
            <a:ext cx="8785225" cy="1069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b="1" dirty="0"/>
              <a:t>Figure S2. </a:t>
            </a:r>
            <a:r>
              <a:rPr lang="en-US" sz="1600" dirty="0"/>
              <a:t>PCA plot of 25 insular </a:t>
            </a:r>
            <a:r>
              <a:rPr lang="en-US" sz="1600" dirty="0" smtClean="0"/>
              <a:t>and </a:t>
            </a:r>
            <a:r>
              <a:rPr lang="en-US" sz="1600" dirty="0"/>
              <a:t>continental goats for coordinate PC1 against PC2, PC3 and PC4  averaged </a:t>
            </a:r>
            <a:r>
              <a:rPr lang="en-US" sz="1600" dirty="0" smtClean="0"/>
              <a:t>across individuals</a:t>
            </a:r>
            <a:r>
              <a:rPr lang="en-US" sz="1600" dirty="0"/>
              <a:t>. Red and dark blue indicate insular and continental breeds</a:t>
            </a:r>
            <a:r>
              <a:rPr lang="en-US" sz="1600"/>
              <a:t>, </a:t>
            </a:r>
            <a:r>
              <a:rPr lang="en-US" sz="1600" smtClean="0"/>
              <a:t>respectively, </a:t>
            </a:r>
            <a:r>
              <a:rPr lang="en-US" sz="1600" dirty="0"/>
              <a:t>with high homozygosity. Pink and light blue indicate insular and continental breeds, respectively, with low or modest homozygosity.</a:t>
            </a:r>
            <a:r>
              <a:rPr lang="es-ES" sz="1600" dirty="0"/>
              <a:t> </a:t>
            </a:r>
            <a:endParaRPr 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0</Words>
  <Application>Microsoft Office PowerPoint</Application>
  <PresentationFormat>Presentación en pantalla (4:3)</PresentationFormat>
  <Paragraphs>83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o Office</vt:lpstr>
      <vt:lpstr>Presentación de PowerPoint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tfcardoso</dc:creator>
  <cp:lastModifiedBy>ma</cp:lastModifiedBy>
  <cp:revision>6</cp:revision>
  <dcterms:created xsi:type="dcterms:W3CDTF">2018-04-02T12:05:58Z</dcterms:created>
  <dcterms:modified xsi:type="dcterms:W3CDTF">2018-07-06T13:53:03Z</dcterms:modified>
</cp:coreProperties>
</file>